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0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142375" y="4558462"/>
            <a:ext cx="197971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. S2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mino acid sequence alignment of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OsPUB73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with other V class genes in rice and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Arabidopsis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 descr="D:\论文\投稿论文\第四篇\附图\V类泛素-3-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111959"/>
            <a:ext cx="6984776" cy="64735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81027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9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PC</cp:lastModifiedBy>
  <cp:revision>7</cp:revision>
  <dcterms:created xsi:type="dcterms:W3CDTF">2019-06-13T02:47:12Z</dcterms:created>
  <dcterms:modified xsi:type="dcterms:W3CDTF">2019-10-18T11:31:58Z</dcterms:modified>
</cp:coreProperties>
</file>